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B38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 varScale="1">
        <p:scale>
          <a:sx n="85" d="100"/>
          <a:sy n="85" d="100"/>
        </p:scale>
        <p:origin x="33" y="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56D1BB-FF46-47D6-BF9B-BD05FDF842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A02215-39DF-44D3-B860-FD4B693820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382EB5-A3DB-442A-8A9E-AF719E5D4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F51F49-8F9A-47DA-8E72-17B51ECA3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4A4E06-D4DB-42D6-8D78-05CEE9213D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77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82F470-FD33-4BFF-8293-926FBD9C7D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243CF5-4CE3-477C-85B8-ED3AA94834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D3A9B4-B93F-4277-95E3-6D800B694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51C1E0-891C-4A1C-AD50-526F0C6B8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1C4D0F-5CC8-4C43-8DFC-34623DDBE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272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CEBD55-0CB0-4D7B-9DFB-1A775F0C0E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BDD5D9-63CE-4193-8C32-C2D775E32F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768FCC-C96B-47B9-BBBF-18FAF648D1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4F804C-5A02-440C-B607-7F2019357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6A1E7F-9C30-442A-9C53-333328AD1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374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1A7F1A-ABED-4AB0-9EAB-50BCDCA60E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4E26BF-D973-4A9B-860A-319E222660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09ACAD-1E4E-4786-8BF4-3DB946A972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93DBCF-6B8F-4DDE-8EFD-45E0B955A8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2F6EBC-A674-4437-B44B-816C3CB993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1442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452EC-73BF-4954-A336-5B6E76D02F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4ED36F-8D19-4A1C-B8F4-1D8A170B04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07A8DA-D2F3-4DF9-85B4-C325F6483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CEF1C7-4EA6-457E-B675-8F0B8E10E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535348-F8A4-4DEC-9C77-4CA4A9CC9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1065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150405-1E6A-44D5-9F55-B15796E4DA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93D96E-E35C-4F33-9D4B-072EDB0ABB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3D7213-FCDD-4519-91EB-9BC5429C3A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A26069-D3EF-42A0-BDA0-CA90CBD06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D3E61A-1029-410C-990A-8F803D79D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679EEF-125C-4298-915F-A60D60B42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596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468DD7-0E7A-4A11-9CBC-F644B77EA2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E3A277-6896-4D2C-8506-1BA9E73930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A02ECA-F653-41DE-8DC8-44BDEE2183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6E9F117-1061-4747-8F34-EC86CFD63C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EF119C-1575-4871-89B8-CB3C0C444F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44B8E8B-A228-467A-887B-083DBA845D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4A3204F-186A-4BB6-B38A-A305B7CA7F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9290303-13A4-4C31-A524-D3576DB6FA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011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235B58-EEF7-4CCC-BD12-52EFD54861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5E87EA-5F2F-4FC2-8F34-E81F134CD8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F746099-76EF-4488-835D-F97105C602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0D840E6-93A9-4221-BD1F-95E76D4822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911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E7897E-777F-4029-ABC0-15AC7B2227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34839BB-3015-494B-87E9-3B884F98FE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BAC4A5-B1B0-4BFB-AB19-5F75FEDA6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595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868EF1-7304-4832-BE13-D6D1E6263F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4AE976-F1B5-456F-988A-F7A495B13F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2A9068-C470-4EF5-8C85-96F2FC83FB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2F63B6-94A1-474A-8968-9E35BF5E1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9A4307-1318-4570-836D-24020A40FF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ADD920-3BDA-4BAA-AA05-A733E756E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589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348363-F62C-43CE-A869-EB35F4B1FE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F97CA5-534E-444B-922E-1C1709940A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0188BE-0C55-4875-8A81-793D908473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09B25F-B387-44C9-B60A-A0A5767789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671725-BEFA-4ACD-B702-F750F02AD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BFBE16-498A-4D36-B1EC-6B6631ADE7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973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C3235F4-271B-4F58-8087-F4740ED26E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6DD009-584F-4F1C-9084-AAEB1AB636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5B5B1E-8780-4805-8B18-788487818A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B839AF-00F6-4D5C-A4AE-8B7E50D788F0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2C4F6E-1E11-4E2B-88A8-E613E0D6CD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3DFFB2-2F7D-487A-9FC0-EB03943860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842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Rectangle 18">
            <a:extLst>
              <a:ext uri="{FF2B5EF4-FFF2-40B4-BE49-F238E27FC236}">
                <a16:creationId xmlns:a16="http://schemas.microsoft.com/office/drawing/2014/main" id="{4A26C853-1B3B-456E-AC56-9D817CF6BF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57588" y="1580197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058AD9A4-29C5-4251-986F-DFAD78EBD20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1516627"/>
              </p:ext>
            </p:extLst>
          </p:nvPr>
        </p:nvGraphicFramePr>
        <p:xfrm>
          <a:off x="57150" y="1"/>
          <a:ext cx="6889765" cy="6797829"/>
        </p:xfrm>
        <a:graphic>
          <a:graphicData uri="http://schemas.openxmlformats.org/drawingml/2006/table">
            <a:tbl>
              <a:tblPr firstRow="1" bandRow="1"/>
              <a:tblGrid>
                <a:gridCol w="1227971">
                  <a:extLst>
                    <a:ext uri="{9D8B030D-6E8A-4147-A177-3AD203B41FA5}">
                      <a16:colId xmlns:a16="http://schemas.microsoft.com/office/drawing/2014/main" val="671167128"/>
                    </a:ext>
                  </a:extLst>
                </a:gridCol>
                <a:gridCol w="1637297">
                  <a:extLst>
                    <a:ext uri="{9D8B030D-6E8A-4147-A177-3AD203B41FA5}">
                      <a16:colId xmlns:a16="http://schemas.microsoft.com/office/drawing/2014/main" val="3509596363"/>
                    </a:ext>
                  </a:extLst>
                </a:gridCol>
                <a:gridCol w="1637297">
                  <a:extLst>
                    <a:ext uri="{9D8B030D-6E8A-4147-A177-3AD203B41FA5}">
                      <a16:colId xmlns:a16="http://schemas.microsoft.com/office/drawing/2014/main" val="253827510"/>
                    </a:ext>
                  </a:extLst>
                </a:gridCol>
                <a:gridCol w="1637297">
                  <a:extLst>
                    <a:ext uri="{9D8B030D-6E8A-4147-A177-3AD203B41FA5}">
                      <a16:colId xmlns:a16="http://schemas.microsoft.com/office/drawing/2014/main" val="1423811462"/>
                    </a:ext>
                  </a:extLst>
                </a:gridCol>
                <a:gridCol w="188503">
                  <a:extLst>
                    <a:ext uri="{9D8B030D-6E8A-4147-A177-3AD203B41FA5}">
                      <a16:colId xmlns:a16="http://schemas.microsoft.com/office/drawing/2014/main" val="2193219143"/>
                    </a:ext>
                  </a:extLst>
                </a:gridCol>
                <a:gridCol w="561400">
                  <a:extLst>
                    <a:ext uri="{9D8B030D-6E8A-4147-A177-3AD203B41FA5}">
                      <a16:colId xmlns:a16="http://schemas.microsoft.com/office/drawing/2014/main" val="1165637016"/>
                    </a:ext>
                  </a:extLst>
                </a:gridCol>
              </a:tblGrid>
              <a:tr h="92694">
                <a:tc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i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PAFB </a:t>
                      </a:r>
                      <a:r>
                        <a:rPr lang="en-US" sz="1000" i="1" kern="12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sz="1000" i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(µg/m³)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i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JBC </a:t>
                      </a:r>
                      <a:r>
                        <a:rPr lang="en-US" sz="1000" i="1" kern="12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++</a:t>
                      </a:r>
                      <a:r>
                        <a:rPr lang="en-US" sz="1000" i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µg/m³)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80645516"/>
                  </a:ext>
                </a:extLst>
              </a:tr>
              <a:tr h="268116">
                <a:tc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 ±SEM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spirable ±SEM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 ±SEM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spirable ±SEM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26527168"/>
                  </a:ext>
                </a:extLst>
              </a:tr>
              <a:tr h="95685">
                <a:tc>
                  <a:txBody>
                    <a:bodyPr/>
                    <a:lstStyle/>
                    <a:p>
                      <a:pPr marL="0" marR="0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uminum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11" marR="3511" marT="35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32169247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2 ± 0.1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36 ± 0.8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24914976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81 ± 0.76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8813092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da-DK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9/M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4 ± 0.13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3 ± 0.6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2 ± 0.0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5 ± 0.56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80275487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trols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7 ± 0.1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9 ± 0.1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3 ± 0.06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 ± 0.1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76762023"/>
                  </a:ext>
                </a:extLst>
              </a:tr>
              <a:tr h="95685">
                <a:tc>
                  <a:txBody>
                    <a:bodyPr/>
                    <a:lstStyle/>
                    <a:p>
                      <a:pPr marL="0" marR="0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lcium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11" marR="3511" marT="35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26151377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62910794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44201531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da-DK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9/M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.53 ± 4.6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1220410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trols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12 ± 2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26528623"/>
                  </a:ext>
                </a:extLst>
              </a:tr>
              <a:tr h="95685">
                <a:tc>
                  <a:txBody>
                    <a:bodyPr/>
                    <a:lstStyle/>
                    <a:p>
                      <a:pPr marL="0" marR="0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romium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11" marR="3511" marT="35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31890661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1 ± 0.1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8 ± 0.23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7401347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 ± 0.0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4 ± 0.0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5236344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da-DK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9/M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 ± 0.03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53258551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trols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9692061"/>
                  </a:ext>
                </a:extLst>
              </a:tr>
              <a:tr h="95685">
                <a:tc>
                  <a:txBody>
                    <a:bodyPr/>
                    <a:lstStyle/>
                    <a:p>
                      <a:pPr marL="0" marR="0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agnesium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11" marR="3511" marT="35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30872118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4 ± 0.5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52201870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3 ± 0.1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9 ± 0.3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93175747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da-DK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9/M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7 ± 0.1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5 ± 0.0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.01 ± 6.6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72282376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trols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2486669"/>
                  </a:ext>
                </a:extLst>
              </a:tr>
              <a:tr h="95685">
                <a:tc>
                  <a:txBody>
                    <a:bodyPr/>
                    <a:lstStyle/>
                    <a:p>
                      <a:pPr marL="0" marR="0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tassium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11" marR="3511" marT="35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27591653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47879481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.72 ± 3.4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.84 ± 3.6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4367573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da-DK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9/M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 ± 0.0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.60 ± 2.9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.97 ± 5.0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69065145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trols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1678450"/>
                  </a:ext>
                </a:extLst>
              </a:tr>
              <a:tr h="95685">
                <a:tc>
                  <a:txBody>
                    <a:bodyPr/>
                    <a:lstStyle/>
                    <a:p>
                      <a:pPr marL="0" marR="0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in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11" marR="3511" marT="35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96506975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9 ± 0.1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38637050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3 ± 0.1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2 ± 0.1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5 ± 0.1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675775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da-DK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9/M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2 ± 0.13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05 ± 1.8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42 ± 0.1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2 ± 0.11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72207643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trols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89838956"/>
                  </a:ext>
                </a:extLst>
              </a:tr>
              <a:tr h="95685">
                <a:tc>
                  <a:txBody>
                    <a:bodyPr/>
                    <a:lstStyle/>
                    <a:p>
                      <a:pPr marL="0" marR="0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Zinc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3511" marR="3511" marT="351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351613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69583600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1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t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86 ± 0.6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52 ± 0.93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35944827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da-DK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9/M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0 ± 0.0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8 ± 0.0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.61 ± 5.3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.29 ± 1.3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98502844"/>
                  </a:ext>
                </a:extLst>
              </a:tr>
              <a:tr h="176086">
                <a:tc>
                  <a:txBody>
                    <a:bodyPr/>
                    <a:lstStyle/>
                    <a:p>
                      <a:pPr marL="0" marR="0" algn="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trols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20 ± 0.2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 ± 0.0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8" marR="468" marT="4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13500003"/>
                  </a:ext>
                </a:extLst>
              </a:tr>
              <a:tr h="95685">
                <a:tc gridSpan="5">
                  <a:txBody>
                    <a:bodyPr/>
                    <a:lstStyle/>
                    <a:p>
                      <a:pPr marL="0" marR="0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+ 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PAFB sample sizes: n</a:t>
                      </a:r>
                      <a:r>
                        <a:rPr lang="en-US" sz="1000" kern="12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9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=4, n</a:t>
                      </a:r>
                      <a:r>
                        <a:rPr lang="en-US" sz="1000" kern="12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4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=4, n</a:t>
                      </a:r>
                      <a:r>
                        <a:rPr lang="en-US" sz="1000" kern="12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9/M4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=6, n</a:t>
                      </a:r>
                      <a:r>
                        <a:rPr lang="en-US" sz="1000" kern="12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trols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=10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2866086"/>
                  </a:ext>
                </a:extLst>
              </a:tr>
              <a:tr h="120270">
                <a:tc gridSpan="5">
                  <a:txBody>
                    <a:bodyPr/>
                    <a:lstStyle/>
                    <a:p>
                      <a:pPr marL="0" marR="0" fontAlgn="b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kern="12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++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JBC sample sizes: n</a:t>
                      </a:r>
                      <a:r>
                        <a:rPr lang="en-US" sz="1000" kern="12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9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=4, n</a:t>
                      </a:r>
                      <a:r>
                        <a:rPr lang="en-US" sz="1000" kern="12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4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=4, n</a:t>
                      </a:r>
                      <a:r>
                        <a:rPr lang="en-US" sz="1000" kern="12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9/M4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=4, n</a:t>
                      </a:r>
                      <a:r>
                        <a:rPr lang="en-US" sz="1000" kern="12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trols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=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766" marR="10766" marT="3511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36016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293639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460</Words>
  <Application>Microsoft Office PowerPoint</Application>
  <PresentationFormat>Widescreen</PresentationFormat>
  <Paragraphs>17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yan McNeilly</dc:creator>
  <cp:lastModifiedBy>Ryan McNeilly</cp:lastModifiedBy>
  <cp:revision>6</cp:revision>
  <dcterms:created xsi:type="dcterms:W3CDTF">2021-01-12T16:58:12Z</dcterms:created>
  <dcterms:modified xsi:type="dcterms:W3CDTF">2021-02-04T18:46:52Z</dcterms:modified>
</cp:coreProperties>
</file>